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029ABAF-430B-443E-BC9B-DB85D74AE113}" v="4" dt="2024-01-19T20:34:00.8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ADF58E-313D-7318-7A58-C5FE0ED1A3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2F8465-7D9F-A2DD-746D-32811455A2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FBEE2-2E72-064D-2E71-BAB3A3A04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53FAD4-74F9-A794-1799-71F37063D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FF529-720B-C25A-2BE5-D071CF5D2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292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3D74CF-F30C-8F61-A74E-9631B8180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C7E277-1A97-1163-6B15-9771F48D1F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D02B38-CB56-D753-A3ED-D32C8FE2A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E08E3A-B524-F8C5-92C7-C260CC6D1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2B47BA-452A-CAE7-1B6C-77C78FE4C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770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DCD58A-DA10-7452-9A36-097438C72F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880E9B-AFA1-BC67-0050-D7F7E720CB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B7C7E-AA44-B93D-AD1C-4456A3859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3DFD6E-0635-0C6F-A236-5EA4E85FF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B93BA-00E0-8D89-60B6-78368168F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56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0A15D-D088-94A9-A368-94755BEC1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585DD9-A52A-5906-06E6-F57C980273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A0677-F9D4-59F4-92FC-9784D1343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5F3236-14ED-888D-FEAB-825856825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9A4976-AB6E-C4E7-E82A-5047F6416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556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CDCC97-2E75-F730-936C-B110A48CD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61C142-AEB8-0622-9AF9-FD2BDD4E67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8B247-18CF-4639-8B57-7F28538C6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2EA0F-A972-62C1-60C4-E5145E199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1470C-0DE1-1D9E-1FBA-AA1B5F45A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854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BAB76-FFDE-9F11-5C40-AC8CB5F4C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A7B5C4-3EE7-981C-FE96-FBC4355036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0F715A-075E-D3D8-7005-F202EB96EE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6A71FA-7886-D745-1E5F-27B348C5F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5D0F94-6584-AC6E-6AE6-9897D9C69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2B472C-2F72-FF25-3262-BBB8FAEEC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266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2C358-6BD0-C7EC-DE61-7EF2B2B49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BECF8-9901-F3C4-43AA-7C51A6F219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4C8B2E-C13D-BE22-0970-178687994D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96762B-6BAE-1407-5AA6-F8B6DA4320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10D351-F099-DDE2-595B-7082D28CED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4EDFD4-87A5-75CC-903B-B2A366D9F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C514BE-46DA-F954-E193-3B9D4374B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52D3433-35CB-ABB2-A26F-682F3C0BF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39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5F392-1E5B-AAA2-54C1-C9BB5C87C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44DAE2-F625-E2A0-C014-48F79E20D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D79FD7-07EB-3F49-1DD0-FEC2F6A0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1FE7A6-527A-0E0D-9762-65E8D9796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377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A22338-8FC9-B102-4222-667C82A68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AE9CBB-F1F2-2DB4-5603-2E7D56937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6116F6-552A-4466-2DD7-25782FCDD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23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CBE34-3699-EBA3-CCD3-35A9E3761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1BEB1-4583-E735-E444-5B93DC2421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C45BEB-5E5F-28F6-F5CC-09C4733652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DD1784-5DDD-C068-2CF1-5AB8D3719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08EBEF-C70A-E53C-0BFE-FBE254381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C0ADF2-CD5E-1598-476B-F1949AE29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510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3FDA8-753D-8C39-8AFB-E7567DC56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342D08-37B8-73F8-5BF6-AD3607F7ED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36BE9E-34E6-05EB-A83A-D9E81A461F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90A9A6-638F-6F3E-6951-074875981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1A2A3A-543E-EC46-C78D-931992D12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7DDA08-8F7B-8044-EEF9-D8F325C95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814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15EDF6-717A-1865-8F12-4DC4CF6D55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3C7DB8-EA45-BF79-D6EB-1D09977B8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C441D-6118-C19B-132D-71E5906B1E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4837C7-9D63-4AB8-953A-C90F61153F45}" type="datetimeFigureOut">
              <a:rPr lang="en-US" smtClean="0"/>
              <a:t>9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8C79D9-6A86-C4AB-5597-70977F427B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D3FABE-2693-2AD5-BB87-57DE12FBD5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279B5F-BAE2-4781-B5A2-5DA5B43693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89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BDE85EC-FD65-38D2-725E-5627BEE838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0982" y="509777"/>
            <a:ext cx="6495178" cy="459718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90513D8-DA02-EA13-23D8-E395315FE740}"/>
              </a:ext>
            </a:extLst>
          </p:cNvPr>
          <p:cNvSpPr txBox="1"/>
          <p:nvPr/>
        </p:nvSpPr>
        <p:spPr>
          <a:xfrm>
            <a:off x="2660468" y="5147772"/>
            <a:ext cx="64414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S1 The map of 14 sates covered by this study. Sates labeled in green are states we have isolated strains from.</a:t>
            </a:r>
          </a:p>
        </p:txBody>
      </p:sp>
    </p:spTree>
    <p:extLst>
      <p:ext uri="{BB962C8B-B14F-4D97-AF65-F5344CB8AC3E}">
        <p14:creationId xmlns:p14="http://schemas.microsoft.com/office/powerpoint/2010/main" val="15090199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graph&#10;&#10;Description automatically generated">
            <a:extLst>
              <a:ext uri="{FF2B5EF4-FFF2-40B4-BE49-F238E27FC236}">
                <a16:creationId xmlns:a16="http://schemas.microsoft.com/office/drawing/2014/main" id="{EB2C52F5-317C-A4C3-9BBF-DB707A3749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763" y="278350"/>
            <a:ext cx="9027042" cy="48387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D73A888-B383-0B2C-2385-736F0E5156C4}"/>
              </a:ext>
            </a:extLst>
          </p:cNvPr>
          <p:cNvSpPr txBox="1"/>
          <p:nvPr/>
        </p:nvSpPr>
        <p:spPr>
          <a:xfrm>
            <a:off x="2225040" y="5659120"/>
            <a:ext cx="5953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S2. De novo assembly quality statistics by three sequencing methods. </a:t>
            </a:r>
          </a:p>
        </p:txBody>
      </p:sp>
    </p:spTree>
    <p:extLst>
      <p:ext uri="{BB962C8B-B14F-4D97-AF65-F5344CB8AC3E}">
        <p14:creationId xmlns:p14="http://schemas.microsoft.com/office/powerpoint/2010/main" val="3433166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ng Ma</dc:creator>
  <cp:lastModifiedBy>Abby Rassette</cp:lastModifiedBy>
  <cp:revision>2</cp:revision>
  <dcterms:created xsi:type="dcterms:W3CDTF">2024-01-19T20:31:54Z</dcterms:created>
  <dcterms:modified xsi:type="dcterms:W3CDTF">2024-09-04T09:13:27Z</dcterms:modified>
</cp:coreProperties>
</file>